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6" r:id="rId2"/>
    <p:sldId id="280" r:id="rId3"/>
    <p:sldId id="271" r:id="rId4"/>
    <p:sldId id="281" r:id="rId5"/>
    <p:sldId id="28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0C8BAE5D-3A95-4EAD-BFE5-E539AAD3314D}">
          <p14:sldIdLst>
            <p14:sldId id="276"/>
            <p14:sldId id="280"/>
            <p14:sldId id="271"/>
            <p14:sldId id="281"/>
            <p14:sldId id="28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283" userDrawn="1">
          <p15:clr>
            <a:srgbClr val="A4A3A4"/>
          </p15:clr>
        </p15:guide>
        <p15:guide id="2" pos="2205" userDrawn="1">
          <p15:clr>
            <a:srgbClr val="A4A3A4"/>
          </p15:clr>
        </p15:guide>
        <p15:guide id="3" pos="618" userDrawn="1">
          <p15:clr>
            <a:srgbClr val="A4A3A4"/>
          </p15:clr>
        </p15:guide>
        <p15:guide id="4" orient="horz" pos="6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6600"/>
    <a:srgbClr val="C00000"/>
    <a:srgbClr val="FF9999"/>
    <a:srgbClr val="9DC3E6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67" autoAdjust="0"/>
    <p:restoredTop sz="96101" autoAdjust="0"/>
  </p:normalViewPr>
  <p:slideViewPr>
    <p:cSldViewPr snapToGrid="0" showGuides="1">
      <p:cViewPr varScale="1">
        <p:scale>
          <a:sx n="72" d="100"/>
          <a:sy n="72" d="100"/>
        </p:scale>
        <p:origin x="3432" y="60"/>
      </p:cViewPr>
      <p:guideLst>
        <p:guide orient="horz" pos="1283"/>
        <p:guide pos="2205"/>
        <p:guide pos="618"/>
        <p:guide orient="horz" pos="60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정연주" userId="697843259_tp_dropbox_plus" providerId="OAuth2" clId="{F5E0C0E0-FB1F-45ED-9CB3-F49677FEE0C3}"/>
    <pc:docChg chg="undo custSel addSld delSld modSld modSection">
      <pc:chgData name="정연주" userId="697843259_tp_dropbox_plus" providerId="OAuth2" clId="{F5E0C0E0-FB1F-45ED-9CB3-F49677FEE0C3}" dt="2026-05-06T00:32:14.786" v="23" actId="13926"/>
      <pc:docMkLst>
        <pc:docMk/>
      </pc:docMkLst>
      <pc:sldChg chg="addSp delSp modSp add del mod">
        <pc:chgData name="정연주" userId="697843259_tp_dropbox_plus" providerId="OAuth2" clId="{F5E0C0E0-FB1F-45ED-9CB3-F49677FEE0C3}" dt="2026-05-06T00:32:14.786" v="23" actId="13926"/>
        <pc:sldMkLst>
          <pc:docMk/>
          <pc:sldMk cId="3994404800" sldId="271"/>
        </pc:sldMkLst>
        <pc:spChg chg="add del mod">
          <ac:chgData name="정연주" userId="697843259_tp_dropbox_plus" providerId="OAuth2" clId="{F5E0C0E0-FB1F-45ED-9CB3-F49677FEE0C3}" dt="2026-02-26T02:36:33.221" v="2" actId="478"/>
          <ac:spMkLst>
            <pc:docMk/>
            <pc:sldMk cId="3994404800" sldId="271"/>
            <ac:spMk id="3" creationId="{1A5583A0-581B-043D-52BE-6192D0534C4B}"/>
          </ac:spMkLst>
        </pc:spChg>
        <pc:spChg chg="del mod">
          <ac:chgData name="정연주" userId="697843259_tp_dropbox_plus" providerId="OAuth2" clId="{F5E0C0E0-FB1F-45ED-9CB3-F49677FEE0C3}" dt="2026-04-27T03:16:00.005" v="22" actId="478"/>
          <ac:spMkLst>
            <pc:docMk/>
            <pc:sldMk cId="3994404800" sldId="271"/>
            <ac:spMk id="3" creationId="{EADE37DC-284F-E553-BF8A-29B64FA11C8C}"/>
          </ac:spMkLst>
        </pc:spChg>
        <pc:spChg chg="add 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6" creationId="{22602535-D312-CC44-50DC-2F999823C09E}"/>
          </ac:spMkLst>
        </pc:spChg>
        <pc:spChg chg="add 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13" creationId="{FE46B13E-5000-31AB-BF1D-8D3309FDC7E0}"/>
          </ac:spMkLst>
        </pc:spChg>
        <pc:spChg chg="add 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14" creationId="{630279B6-7E7E-CAFB-17E5-25A019C7D8FA}"/>
          </ac:spMkLst>
        </pc:spChg>
        <pc:spChg chg="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18" creationId="{D1A39C93-4929-2525-084A-8B3FE3D8CE79}"/>
          </ac:spMkLst>
        </pc:spChg>
        <pc:spChg chg="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19" creationId="{43DE1943-439E-64B7-DB5B-C48AFAA76403}"/>
          </ac:spMkLst>
        </pc:spChg>
        <pc:spChg chg="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20" creationId="{B2AA845F-C214-A8DE-00E8-2AED85925464}"/>
          </ac:spMkLst>
        </pc:spChg>
        <pc:spChg chg="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26" creationId="{B55FDEAC-4FAA-575C-87CD-F9BC794B4858}"/>
          </ac:spMkLst>
        </pc:spChg>
        <pc:spChg chg="mod">
          <ac:chgData name="정연주" userId="697843259_tp_dropbox_plus" providerId="OAuth2" clId="{F5E0C0E0-FB1F-45ED-9CB3-F49677FEE0C3}" dt="2026-02-26T02:36:33.993" v="3"/>
          <ac:spMkLst>
            <pc:docMk/>
            <pc:sldMk cId="3994404800" sldId="271"/>
            <ac:spMk id="28" creationId="{E9000336-A7B4-9306-1819-C5051B0E8873}"/>
          </ac:spMkLst>
        </pc:spChg>
        <pc:spChg chg="mod">
          <ac:chgData name="정연주" userId="697843259_tp_dropbox_plus" providerId="OAuth2" clId="{F5E0C0E0-FB1F-45ED-9CB3-F49677FEE0C3}" dt="2026-05-06T00:32:14.786" v="23" actId="13926"/>
          <ac:spMkLst>
            <pc:docMk/>
            <pc:sldMk cId="3994404800" sldId="271"/>
            <ac:spMk id="38" creationId="{9504AEF4-55BF-1183-1149-780CB9D44A1A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53" creationId="{CADF5881-80B7-394C-2DB8-6F1D73F5FFAA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58" creationId="{C3AFFC69-D90D-5F9D-EF2B-218254B60216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59" creationId="{8EAD0D46-F48C-983A-BB61-D404E4DAD330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60" creationId="{BB622088-6F23-4B81-8E8D-303C7F2E1577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61" creationId="{6EE0AA8C-328B-4E4F-9792-45AE6A234754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62" creationId="{DA47F94A-BB1D-72B1-6E8E-E550E852C34C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63" creationId="{50175DA9-6FB3-2F91-3E4F-2ABA89AA1F30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66" creationId="{1E60912D-41E5-327F-6F2A-ED9FBBF4EA69}"/>
          </ac:spMkLst>
        </pc:spChg>
        <pc:spChg chg="mod">
          <ac:chgData name="정연주" userId="697843259_tp_dropbox_plus" providerId="OAuth2" clId="{F5E0C0E0-FB1F-45ED-9CB3-F49677FEE0C3}" dt="2026-02-27T00:42:19.910" v="9" actId="14861"/>
          <ac:spMkLst>
            <pc:docMk/>
            <pc:sldMk cId="3994404800" sldId="271"/>
            <ac:spMk id="68" creationId="{6821C6F5-EED4-0988-AC88-C9059FB31CFA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69" creationId="{72AA5C90-58C1-26E4-2A3A-CCF95B9657E1}"/>
          </ac:spMkLst>
        </pc:spChg>
        <pc:spChg chg="mod">
          <ac:chgData name="정연주" userId="697843259_tp_dropbox_plus" providerId="OAuth2" clId="{F5E0C0E0-FB1F-45ED-9CB3-F49677FEE0C3}" dt="2026-02-27T00:42:44.272" v="10" actId="14861"/>
          <ac:spMkLst>
            <pc:docMk/>
            <pc:sldMk cId="3994404800" sldId="271"/>
            <ac:spMk id="70" creationId="{C5D877FB-E7AB-9612-E236-F3AB52849D15}"/>
          </ac:spMkLst>
        </pc:spChg>
        <pc:picChg chg="add mod">
          <ac:chgData name="정연주" userId="697843259_tp_dropbox_plus" providerId="OAuth2" clId="{F5E0C0E0-FB1F-45ED-9CB3-F49677FEE0C3}" dt="2026-02-26T02:36:33.993" v="3"/>
          <ac:picMkLst>
            <pc:docMk/>
            <pc:sldMk cId="3994404800" sldId="271"/>
            <ac:picMk id="7" creationId="{603C586C-82BC-123F-282D-6A7F0FDEF921}"/>
          </ac:picMkLst>
        </pc:picChg>
        <pc:picChg chg="add mod">
          <ac:chgData name="정연주" userId="697843259_tp_dropbox_plus" providerId="OAuth2" clId="{F5E0C0E0-FB1F-45ED-9CB3-F49677FEE0C3}" dt="2026-02-26T02:36:33.993" v="3"/>
          <ac:picMkLst>
            <pc:docMk/>
            <pc:sldMk cId="3994404800" sldId="271"/>
            <ac:picMk id="15" creationId="{99AEC8A8-7CD4-CDDF-EB7E-FE8C477CB4EF}"/>
          </ac:picMkLst>
        </pc:picChg>
      </pc:sldChg>
      <pc:sldChg chg="del">
        <pc:chgData name="정연주" userId="697843259_tp_dropbox_plus" providerId="OAuth2" clId="{F5E0C0E0-FB1F-45ED-9CB3-F49677FEE0C3}" dt="2026-04-03T00:18:59.236" v="11" actId="47"/>
        <pc:sldMkLst>
          <pc:docMk/>
          <pc:sldMk cId="2187689607" sldId="278"/>
        </pc:sldMkLst>
      </pc:sldChg>
      <pc:sldChg chg="del">
        <pc:chgData name="정연주" userId="697843259_tp_dropbox_plus" providerId="OAuth2" clId="{F5E0C0E0-FB1F-45ED-9CB3-F49677FEE0C3}" dt="2026-04-03T00:19:01.783" v="12" actId="47"/>
        <pc:sldMkLst>
          <pc:docMk/>
          <pc:sldMk cId="2713521094" sldId="279"/>
        </pc:sldMkLst>
      </pc:sldChg>
      <pc:sldChg chg="del">
        <pc:chgData name="정연주" userId="697843259_tp_dropbox_plus" providerId="OAuth2" clId="{F5E0C0E0-FB1F-45ED-9CB3-F49677FEE0C3}" dt="2026-02-26T02:22:59.375" v="0" actId="47"/>
        <pc:sldMkLst>
          <pc:docMk/>
          <pc:sldMk cId="1343193020" sldId="283"/>
        </pc:sldMkLst>
      </pc:sldChg>
      <pc:sldChg chg="delSp add mod">
        <pc:chgData name="정연주" userId="697843259_tp_dropbox_plus" providerId="OAuth2" clId="{F5E0C0E0-FB1F-45ED-9CB3-F49677FEE0C3}" dt="2026-04-22T01:52:02.024" v="18" actId="478"/>
        <pc:sldMkLst>
          <pc:docMk/>
          <pc:sldMk cId="3631747797" sldId="283"/>
        </pc:sldMkLst>
        <pc:spChg chg="del">
          <ac:chgData name="정연주" userId="697843259_tp_dropbox_plus" providerId="OAuth2" clId="{F5E0C0E0-FB1F-45ED-9CB3-F49677FEE0C3}" dt="2026-04-22T01:52:02.024" v="18" actId="478"/>
          <ac:spMkLst>
            <pc:docMk/>
            <pc:sldMk cId="3631747797" sldId="283"/>
            <ac:spMk id="117" creationId="{212DCBEF-1FEA-F94A-DE09-6A01ECE2BE1B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FEFCDA-8BF3-48C3-8864-E2EF4CDC9FFF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90F86-B01B-4E02-9F4A-937E813842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4494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ko-KR" altLang="en-US" dirty="0"/>
              <a:t>여러 버전의 프로모터 시퀀스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390F86-B01B-4E02-9F4A-937E8138421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9565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B187D4E-DC5D-E21B-611B-EABDC89E3D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5439AEB5-1CB7-BBC0-8E84-32ABEB8DC07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035757AD-C552-4EB2-A4B2-BEF28723A34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AV: </a:t>
            </a:r>
            <a:r>
              <a: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Cpf1</a:t>
            </a:r>
            <a:r>
              <a:rPr lang="ko-KR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&amp; effect of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oly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signal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xchange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NIH3T3)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109AB05-1B8B-C0BB-C6D1-E48A1DC8146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390F86-B01B-4E02-9F4A-937E81384211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53195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951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4558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3472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08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7988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978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889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400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6327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05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4760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14DE75-CFD7-491F-9032-1234B48DC0DD}" type="datetimeFigureOut">
              <a:rPr lang="ko-KR" altLang="en-US" smtClean="0"/>
              <a:t>2026-05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889E80-6AB7-404F-9111-A656DEA4C0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225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11.png"/><Relationship Id="rId4" Type="http://schemas.openxmlformats.org/officeDocument/2006/relationships/image" Target="../media/image10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BD2E0C-654E-820F-FB15-D8A186A73F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EDFBB16-9BF5-DFB3-1A6D-771EA6379E55}"/>
              </a:ext>
            </a:extLst>
          </p:cNvPr>
          <p:cNvSpPr txBox="1"/>
          <p:nvPr/>
        </p:nvSpPr>
        <p:spPr>
          <a:xfrm>
            <a:off x="337291" y="5758366"/>
            <a:ext cx="6119999" cy="336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Figure S1. Sequences of five bidirectional H1 promoters depicted in Figure. 1B.</a:t>
            </a:r>
            <a:endParaRPr lang="ko-KR" altLang="ko-KR" sz="1200" dirty="0">
              <a:effectLst/>
              <a:latin typeface="Times New Roman" panose="02020603050405020304" pitchFamily="18" charset="0"/>
              <a:ea typeface="굴림" panose="020B0600000101010101" pitchFamily="50" charset="-127"/>
            </a:endParaRP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330D8FDD-A3FA-ACBA-3E3E-611937E686D3}"/>
              </a:ext>
            </a:extLst>
          </p:cNvPr>
          <p:cNvGrpSpPr/>
          <p:nvPr/>
        </p:nvGrpSpPr>
        <p:grpSpPr>
          <a:xfrm>
            <a:off x="337291" y="649059"/>
            <a:ext cx="6151709" cy="5202783"/>
            <a:chOff x="337291" y="649059"/>
            <a:chExt cx="6151709" cy="5202783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51CCA6A-2732-E6BC-0487-40F2E47F971C}"/>
                </a:ext>
              </a:extLst>
            </p:cNvPr>
            <p:cNvSpPr txBox="1"/>
            <p:nvPr/>
          </p:nvSpPr>
          <p:spPr>
            <a:xfrm>
              <a:off x="337291" y="650418"/>
              <a:ext cx="5748559" cy="52014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altLang="ko-K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1"/>
              <a:r>
                <a:rPr lang="en-US" altLang="ko-KR" sz="1000" b="1" dirty="0">
                  <a:solidFill>
                    <a:srgbClr val="0000FF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T</a:t>
              </a:r>
              <a:r>
                <a:rPr lang="en-US" altLang="ko-KR" sz="1000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TTCAGGATGTAGACCGGCCGCCACTATAAGGCTCGAAAGAGGAATAAATTTTTCGTTTAGGGTGATTTCCCACAAAGCACAGCGCGTAATTTGCATGCGCTCTACCCCAGGCTCCTGTGCTAGAC</a:t>
              </a:r>
              <a:r>
                <a:rPr lang="en-US" altLang="ko-KR" sz="1000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GCCACC</a:t>
              </a:r>
              <a:r>
                <a:rPr lang="en-US" altLang="ko-KR" sz="1000" i="1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TGG</a:t>
              </a:r>
              <a:r>
                <a:rPr lang="en-US" altLang="ko-KR" sz="1000" i="1" kern="10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CCCAAAGAAGAAGCGGAAGGTC ~</a:t>
              </a:r>
              <a:endParaRPr lang="ko-KR" altLang="ko-KR" sz="1000" i="1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  <a:p>
              <a:pPr marL="800100" lvl="1" indent="-342900">
                <a:buFontTx/>
                <a:buAutoNum type="arabicPeriod"/>
              </a:pPr>
              <a:endParaRPr lang="en-US" altLang="ko-KR" sz="1000" u="sng" dirty="0">
                <a:solidFill>
                  <a:srgbClr val="FF0000"/>
                </a:solidFill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marL="800100" lvl="1" indent="-342900">
                <a:buFontTx/>
                <a:buAutoNum type="arabicPeriod"/>
              </a:pP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1"/>
              <a:r>
                <a:rPr lang="en-US" altLang="ko-KR" sz="1000" b="1" dirty="0">
                  <a:solidFill>
                    <a:srgbClr val="0000FF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CC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TCAGGATGTAGACCGGCCGCCACTATAAGGCTCGAAAGAGGAATAAATTTTTCGTTTAGGGTGATTTCCCACAAAGCACAGCGCGTAATTTGCATGCGCTCTACCCCAGGCTCCTGTGCTAGA</a:t>
              </a:r>
              <a:r>
                <a:rPr lang="en-US" altLang="ko-KR" sz="1000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AGAAGCCCGCGCATCCGGGCAAGGGATGATGACGTCGTCCTTCAAGAGCGACCGGT</a:t>
              </a:r>
              <a:r>
                <a:rPr lang="en-US" altLang="ko-KR" sz="1000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GCCACC</a:t>
              </a:r>
              <a:r>
                <a:rPr lang="en-US" altLang="ko-KR" sz="1000" i="1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TGG</a:t>
              </a:r>
              <a:r>
                <a:rPr lang="en-US" altLang="ko-KR" sz="1000" i="1" kern="10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CCCAAAGAAGAAGCGGAAGGTC ~</a:t>
              </a:r>
              <a:r>
                <a:rPr lang="en-US" altLang="ko-KR" sz="1000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</a:t>
              </a:r>
            </a:p>
            <a:p>
              <a:pPr marL="800100" lvl="1" indent="-342900">
                <a:buFontTx/>
                <a:buAutoNum type="arabicPeriod"/>
              </a:pPr>
              <a:endParaRPr lang="en-US" altLang="ko-KR" sz="1000" u="sng" dirty="0">
                <a:solidFill>
                  <a:srgbClr val="FF0000"/>
                </a:solidFill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lvl="1"/>
              <a:r>
                <a:rPr lang="en-US" altLang="ko-KR" sz="1000" b="1" dirty="0">
                  <a:solidFill>
                    <a:srgbClr val="0000FF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T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TCAGGATGTAGACCGGCCGCCACTATAAGGCTCGAAAGAGGAATAAATTTTTCGTTTAGGGTGATTTCCCACAAAGCACAGCGCGTAATTTGCATGCGCTCTACCCCAGGCTCCTGTGCTAGAC</a:t>
              </a:r>
              <a:r>
                <a:rPr lang="en-US" altLang="ko-KR" sz="1000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AGAAGCCCGCGCATCCGGGCAAGGGATGATGACGTCGTCCTTCAAGAGCGACCGGT</a:t>
              </a:r>
              <a:r>
                <a:rPr lang="en-US" altLang="ko-KR" sz="1000" i="1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TGG</a:t>
              </a:r>
              <a:r>
                <a:rPr lang="en-US" altLang="ko-KR" sz="1000" i="1" kern="10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CCCAAAGAAGAAGCGGAAGGTC ~</a:t>
              </a:r>
              <a:endParaRPr lang="en-US" altLang="ko-KR" sz="1000" dirty="0">
                <a:solidFill>
                  <a:srgbClr val="FF0000"/>
                </a:solidFill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marL="800100" lvl="1" indent="-342900">
                <a:buFontTx/>
                <a:buAutoNum type="arabicPeriod"/>
              </a:pPr>
              <a:endParaRPr lang="en-US" altLang="ko-KR" sz="1000" dirty="0">
                <a:solidFill>
                  <a:srgbClr val="FF0000"/>
                </a:solidFill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lvl="1"/>
              <a:r>
                <a:rPr lang="en-US" altLang="ko-KR" sz="1000" b="1" dirty="0">
                  <a:solidFill>
                    <a:srgbClr val="0000FF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T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TCAGGATGTAGACCGGCCGCCACTATAAGGCTCGAAAGAGGAATAAATTTTTCGTTTAGGGTGATTTCCCACAAAGCACAGCGCGTAATTTGCATGCGCTCTACCCCAGGCTCCTGTGCTAGAC</a:t>
              </a:r>
              <a:r>
                <a:rPr lang="en-US" altLang="ko-KR" sz="1000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AGAAGCCCGCGCATCCGGGCAAGGGATGATGACGTCGTCCTTCAAGAGCGACCGGT</a:t>
              </a:r>
              <a:r>
                <a:rPr lang="en-US" altLang="ko-KR" sz="1000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GCCACC</a:t>
              </a:r>
              <a:r>
                <a:rPr lang="en-US" altLang="ko-KR" sz="1000" i="1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TGG</a:t>
              </a:r>
              <a:r>
                <a:rPr lang="en-US" altLang="ko-KR" sz="1000" i="1" kern="10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CCCAAAGAAGAAGCGGAAGGTC ~</a:t>
              </a:r>
              <a:endParaRPr lang="en-US" altLang="ko-KR" sz="1000" u="sng" dirty="0">
                <a:solidFill>
                  <a:srgbClr val="FF0000"/>
                </a:solidFill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marL="800100" lvl="1" indent="-342900">
                <a:buFontTx/>
                <a:buAutoNum type="arabicPeriod"/>
              </a:pPr>
              <a:endParaRPr lang="en-US" altLang="ko-KR" sz="1000" i="1" u="sng" dirty="0">
                <a:solidFill>
                  <a:srgbClr val="FF0000"/>
                </a:solidFill>
                <a:highlight>
                  <a:srgbClr val="FFFF00"/>
                </a:highlight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lvl="1"/>
              <a:r>
                <a:rPr lang="en-US" altLang="ko-KR" sz="1000" b="1" dirty="0">
                  <a:solidFill>
                    <a:srgbClr val="0000FF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CCT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TCAGGATGTAGACCGGCCGCCACTATAAGGCTCGAAAGAGGAATAAATTTTTCGTTTAGGGTGATTTCCCACAAAGCACAGCGCGTAATTTGCATGCGCTCTACCCCAGGCTCCTGTGCTAGAC</a:t>
              </a:r>
              <a:r>
                <a:rPr lang="en-US" altLang="ko-KR" sz="1000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AGAAGCCCGCGCATCCGGGCAAGGGATGATGACGTCGTCCTTCAAGAGCGACCGGT</a:t>
              </a:r>
              <a:r>
                <a:rPr lang="en-US" altLang="ko-KR" sz="1000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GCCACC</a:t>
              </a:r>
              <a:r>
                <a:rPr lang="en-US" altLang="ko-KR" sz="1000" i="1" u="sng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ATGG</a:t>
              </a:r>
              <a:r>
                <a:rPr lang="en-US" altLang="ko-KR" sz="1000" i="1" kern="10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CCCAAAGAAGAAGCGGAAGGTC ~</a:t>
              </a:r>
              <a:endParaRPr lang="en-US" altLang="ko-KR" sz="1000" u="sng" dirty="0">
                <a:solidFill>
                  <a:srgbClr val="FF0000"/>
                </a:solidFill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pPr marL="342900" indent="-342900">
                <a:buFontTx/>
                <a:buAutoNum type="arabicPeriod"/>
              </a:pPr>
              <a:endParaRPr lang="en-US" altLang="ko-KR" sz="1000" i="1" u="sng" dirty="0">
                <a:solidFill>
                  <a:srgbClr val="FF0000"/>
                </a:solidFill>
                <a:highlight>
                  <a:srgbClr val="FFFF00"/>
                </a:highlight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  <a:p>
              <a:r>
                <a:rPr lang="en-US" altLang="ko-KR" sz="1000" b="1" dirty="0">
                  <a:solidFill>
                    <a:srgbClr val="0000FF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  Blue</a:t>
              </a:r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: </a:t>
              </a:r>
              <a:r>
                <a:rPr lang="en-US" altLang="ko-KR" sz="1000" b="1" i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Trp53</a:t>
              </a:r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crRNA transcription initiation site</a:t>
              </a:r>
            </a:p>
            <a:p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  Black: bH1 promoter core</a:t>
              </a:r>
            </a:p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  Red</a:t>
              </a:r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: 5’ UTR sequence of </a:t>
              </a:r>
              <a:r>
                <a:rPr lang="en-US" altLang="ko-KR" sz="1000" b="1" i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Parp2</a:t>
              </a:r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  Red </a:t>
              </a:r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(underline): Kozak sequence</a:t>
              </a:r>
            </a:p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   Red </a:t>
              </a:r>
              <a:r>
                <a:rPr lang="en-US" altLang="ko-KR" sz="1000" b="1" dirty="0">
                  <a:latin typeface="Arial" panose="020B0604020202020204" pitchFamily="34" charset="0"/>
                  <a:ea typeface="굴림체" panose="020B0609000101010101" pitchFamily="49" charset="-127"/>
                  <a:cs typeface="Arial" panose="020B0604020202020204" pitchFamily="34" charset="0"/>
                </a:rPr>
                <a:t>(italic): SV40-NLS-AsCpf1-P2A-Puro sequence</a:t>
              </a:r>
            </a:p>
            <a:p>
              <a:endParaRPr lang="en-US" altLang="ko-KR" sz="1000" b="1" dirty="0">
                <a:latin typeface="Arial" panose="020B0604020202020204" pitchFamily="34" charset="0"/>
                <a:ea typeface="굴림체" panose="020B0609000101010101" pitchFamily="49" charset="-127"/>
                <a:cs typeface="Arial" panose="020B0604020202020204" pitchFamily="34" charset="0"/>
              </a:endParaRPr>
            </a:p>
          </p:txBody>
        </p:sp>
        <p:sp>
          <p:nvSpPr>
            <p:cNvPr id="109" name="직사각형 108">
              <a:extLst>
                <a:ext uri="{FF2B5EF4-FFF2-40B4-BE49-F238E27FC236}">
                  <a16:creationId xmlns:a16="http://schemas.microsoft.com/office/drawing/2014/main" id="{1CF444DA-EE1D-5155-EC01-7B1BC62DC34F}"/>
                </a:ext>
              </a:extLst>
            </p:cNvPr>
            <p:cNvSpPr/>
            <p:nvPr/>
          </p:nvSpPr>
          <p:spPr>
            <a:xfrm>
              <a:off x="369000" y="649059"/>
              <a:ext cx="6120000" cy="4960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600B67E-4BF3-B1A1-8C77-D5069C0F7049}"/>
                </a:ext>
              </a:extLst>
            </p:cNvPr>
            <p:cNvSpPr txBox="1"/>
            <p:nvPr/>
          </p:nvSpPr>
          <p:spPr>
            <a:xfrm>
              <a:off x="482832" y="79922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36B3D2B-5A55-0E0F-8507-4563069EC92D}"/>
                </a:ext>
              </a:extLst>
            </p:cNvPr>
            <p:cNvSpPr txBox="1"/>
            <p:nvPr/>
          </p:nvSpPr>
          <p:spPr>
            <a:xfrm>
              <a:off x="482832" y="384925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#5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33A5625-A71B-6881-562F-24F1ED27C7EC}"/>
                </a:ext>
              </a:extLst>
            </p:cNvPr>
            <p:cNvSpPr txBox="1"/>
            <p:nvPr/>
          </p:nvSpPr>
          <p:spPr>
            <a:xfrm>
              <a:off x="482832" y="156671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40BD7C9-0CEE-FA41-AEEF-AF80DBB03EA6}"/>
                </a:ext>
              </a:extLst>
            </p:cNvPr>
            <p:cNvSpPr txBox="1"/>
            <p:nvPr/>
          </p:nvSpPr>
          <p:spPr>
            <a:xfrm>
              <a:off x="482832" y="232882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1AEF1CD-52F0-F68D-BAD8-FEF4BAEE4441}"/>
                </a:ext>
              </a:extLst>
            </p:cNvPr>
            <p:cNvSpPr txBox="1"/>
            <p:nvPr/>
          </p:nvSpPr>
          <p:spPr>
            <a:xfrm>
              <a:off x="482832" y="309017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#4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883399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90184B4-CE46-C65A-262A-F7E37A36AC9A}"/>
              </a:ext>
            </a:extLst>
          </p:cNvPr>
          <p:cNvSpPr txBox="1"/>
          <p:nvPr/>
        </p:nvSpPr>
        <p:spPr>
          <a:xfrm>
            <a:off x="437510" y="7411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 descr="창문이(가) 표시된 사진&#10;&#10;자동 생성된 설명">
            <a:extLst>
              <a:ext uri="{FF2B5EF4-FFF2-40B4-BE49-F238E27FC236}">
                <a16:creationId xmlns:a16="http://schemas.microsoft.com/office/drawing/2014/main" id="{4691C393-E8B7-5D22-F4B6-3AA88E82925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77" t="35756" r="57920" b="48501"/>
          <a:stretch/>
        </p:blipFill>
        <p:spPr>
          <a:xfrm>
            <a:off x="933327" y="921027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그림 4" descr="돌이(가) 표시된 사진&#10;&#10;자동 생성된 설명">
            <a:extLst>
              <a:ext uri="{FF2B5EF4-FFF2-40B4-BE49-F238E27FC236}">
                <a16:creationId xmlns:a16="http://schemas.microsoft.com/office/drawing/2014/main" id="{3EE9BBAC-D4FB-C2F4-6358-2B1A3D9A016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7" t="32366" r="51419" b="51893"/>
          <a:stretch/>
        </p:blipFill>
        <p:spPr>
          <a:xfrm>
            <a:off x="2061100" y="921027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C59E22B5-FBC9-0092-045E-26822E412A7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11" t="53235" r="66678" b="31014"/>
          <a:stretch/>
        </p:blipFill>
        <p:spPr>
          <a:xfrm>
            <a:off x="3188873" y="921027"/>
            <a:ext cx="1080655" cy="108065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7D9D8AA2-C89E-1848-4772-E7B4294BEAF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11" t="45897" r="60578" b="38362"/>
          <a:stretch/>
        </p:blipFill>
        <p:spPr>
          <a:xfrm>
            <a:off x="4317300" y="921027"/>
            <a:ext cx="1080655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그림 7" descr="돌이(가) 표시된 사진&#10;&#10;자동 생성된 설명">
            <a:extLst>
              <a:ext uri="{FF2B5EF4-FFF2-40B4-BE49-F238E27FC236}">
                <a16:creationId xmlns:a16="http://schemas.microsoft.com/office/drawing/2014/main" id="{E99EF71D-43CA-4F98-1E17-E498EB5BCA7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78" t="30291" r="33011" b="53958"/>
          <a:stretch/>
        </p:blipFill>
        <p:spPr>
          <a:xfrm>
            <a:off x="933327" y="2046708"/>
            <a:ext cx="1080655" cy="107854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A593A7A9-FAAD-BBCD-6135-F2A39E07942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18" t="42059" r="51278" b="42200"/>
          <a:stretch/>
        </p:blipFill>
        <p:spPr>
          <a:xfrm>
            <a:off x="2061100" y="2046708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그림 9" descr="스피커이(가) 표시된 사진&#10;&#10;자동 생성된 설명">
            <a:extLst>
              <a:ext uri="{FF2B5EF4-FFF2-40B4-BE49-F238E27FC236}">
                <a16:creationId xmlns:a16="http://schemas.microsoft.com/office/drawing/2014/main" id="{3C9C3E7C-7154-4E36-758B-A9C4795F2A0B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36" t="43243" r="59360" b="41015"/>
          <a:stretch/>
        </p:blipFill>
        <p:spPr>
          <a:xfrm>
            <a:off x="3189528" y="2046708"/>
            <a:ext cx="1080000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31C18BE6-289A-9C93-06F9-2449D665956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17" t="28271" r="55472" b="55986"/>
          <a:stretch/>
        </p:blipFill>
        <p:spPr>
          <a:xfrm>
            <a:off x="4317300" y="2046708"/>
            <a:ext cx="1080655" cy="108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BF53DAE-964F-8709-DB7B-A4EE2C712A1B}"/>
              </a:ext>
            </a:extLst>
          </p:cNvPr>
          <p:cNvSpPr txBox="1"/>
          <p:nvPr/>
        </p:nvSpPr>
        <p:spPr>
          <a:xfrm>
            <a:off x="894083" y="886592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445B75A-643E-48C7-778A-798F0C18C55F}"/>
              </a:ext>
            </a:extLst>
          </p:cNvPr>
          <p:cNvSpPr txBox="1"/>
          <p:nvPr/>
        </p:nvSpPr>
        <p:spPr>
          <a:xfrm>
            <a:off x="2014620" y="886592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pY108-EV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36BEA2-5A1C-8BC3-8634-CAFB0C1F9AB5}"/>
              </a:ext>
            </a:extLst>
          </p:cNvPr>
          <p:cNvSpPr txBox="1"/>
          <p:nvPr/>
        </p:nvSpPr>
        <p:spPr>
          <a:xfrm>
            <a:off x="3151165" y="886592"/>
            <a:ext cx="112842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pY108-Trp53CR2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5D4775-B1FB-97C3-D1A7-FD25F22802B8}"/>
              </a:ext>
            </a:extLst>
          </p:cNvPr>
          <p:cNvSpPr txBox="1"/>
          <p:nvPr/>
        </p:nvSpPr>
        <p:spPr>
          <a:xfrm>
            <a:off x="4279592" y="88659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E1826D-A6AF-2E84-066F-F30AA4083A9F}"/>
              </a:ext>
            </a:extLst>
          </p:cNvPr>
          <p:cNvSpPr txBox="1"/>
          <p:nvPr/>
        </p:nvSpPr>
        <p:spPr>
          <a:xfrm>
            <a:off x="894083" y="20122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D8B782-C074-B131-18EF-F51EA7DCCE38}"/>
              </a:ext>
            </a:extLst>
          </p:cNvPr>
          <p:cNvSpPr txBox="1"/>
          <p:nvPr/>
        </p:nvSpPr>
        <p:spPr>
          <a:xfrm>
            <a:off x="2014620" y="20122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18BD9C9-0255-C5F4-92CC-A37997377A51}"/>
              </a:ext>
            </a:extLst>
          </p:cNvPr>
          <p:cNvSpPr txBox="1"/>
          <p:nvPr/>
        </p:nvSpPr>
        <p:spPr>
          <a:xfrm>
            <a:off x="3151165" y="20122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#4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3012DF-4B92-E73F-3670-7501B6333222}"/>
              </a:ext>
            </a:extLst>
          </p:cNvPr>
          <p:cNvSpPr txBox="1"/>
          <p:nvPr/>
        </p:nvSpPr>
        <p:spPr>
          <a:xfrm>
            <a:off x="4279592" y="20122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#5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표 19">
            <a:extLst>
              <a:ext uri="{FF2B5EF4-FFF2-40B4-BE49-F238E27FC236}">
                <a16:creationId xmlns:a16="http://schemas.microsoft.com/office/drawing/2014/main" id="{0D658CD8-2458-B27A-88DD-5E76BB85FC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2251466"/>
              </p:ext>
            </p:extLst>
          </p:nvPr>
        </p:nvGraphicFramePr>
        <p:xfrm>
          <a:off x="933327" y="3545293"/>
          <a:ext cx="4897120" cy="1466850"/>
        </p:xfrm>
        <a:graphic>
          <a:graphicData uri="http://schemas.openxmlformats.org/drawingml/2006/table">
            <a:tbl>
              <a:tblPr/>
              <a:tblGrid>
                <a:gridCol w="884550">
                  <a:extLst>
                    <a:ext uri="{9D8B030D-6E8A-4147-A177-3AD203B41FA5}">
                      <a16:colId xmlns:a16="http://schemas.microsoft.com/office/drawing/2014/main" val="519724251"/>
                    </a:ext>
                  </a:extLst>
                </a:gridCol>
                <a:gridCol w="499342">
                  <a:extLst>
                    <a:ext uri="{9D8B030D-6E8A-4147-A177-3AD203B41FA5}">
                      <a16:colId xmlns:a16="http://schemas.microsoft.com/office/drawing/2014/main" val="282213083"/>
                    </a:ext>
                  </a:extLst>
                </a:gridCol>
                <a:gridCol w="442274">
                  <a:extLst>
                    <a:ext uri="{9D8B030D-6E8A-4147-A177-3AD203B41FA5}">
                      <a16:colId xmlns:a16="http://schemas.microsoft.com/office/drawing/2014/main" val="1502195542"/>
                    </a:ext>
                  </a:extLst>
                </a:gridCol>
                <a:gridCol w="599211">
                  <a:extLst>
                    <a:ext uri="{9D8B030D-6E8A-4147-A177-3AD203B41FA5}">
                      <a16:colId xmlns:a16="http://schemas.microsoft.com/office/drawing/2014/main" val="2212417327"/>
                    </a:ext>
                  </a:extLst>
                </a:gridCol>
                <a:gridCol w="632781">
                  <a:extLst>
                    <a:ext uri="{9D8B030D-6E8A-4147-A177-3AD203B41FA5}">
                      <a16:colId xmlns:a16="http://schemas.microsoft.com/office/drawing/2014/main" val="1108573450"/>
                    </a:ext>
                  </a:extLst>
                </a:gridCol>
                <a:gridCol w="995680">
                  <a:extLst>
                    <a:ext uri="{9D8B030D-6E8A-4147-A177-3AD203B41FA5}">
                      <a16:colId xmlns:a16="http://schemas.microsoft.com/office/drawing/2014/main" val="3389482884"/>
                    </a:ext>
                  </a:extLst>
                </a:gridCol>
                <a:gridCol w="843282">
                  <a:extLst>
                    <a:ext uri="{9D8B030D-6E8A-4147-A177-3AD203B41FA5}">
                      <a16:colId xmlns:a16="http://schemas.microsoft.com/office/drawing/2014/main" val="4187810390"/>
                    </a:ext>
                  </a:extLst>
                </a:gridCol>
              </a:tblGrid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struct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Promot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Koz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맑은 고딕" panose="020B0503020000020004" pitchFamily="50" charset="-127"/>
                        </a:rPr>
                        <a:t>¢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uromycin</a:t>
                      </a:r>
                      <a:b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</a:b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esistanc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ndel</a:t>
                      </a:r>
                    </a:p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ctiv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633048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tar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n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952396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2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sym typeface="Symbol" panose="05050102010706020507" pitchFamily="18" charset="2"/>
                        </a:rPr>
                        <a:t>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310807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+++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362434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+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83166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++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471849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+++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9874843"/>
                  </a:ext>
                </a:extLst>
              </a:tr>
            </a:tbl>
          </a:graphicData>
        </a:graphic>
      </p:graphicFrame>
      <p:sp>
        <p:nvSpPr>
          <p:cNvPr id="115" name="직사각형 114">
            <a:extLst>
              <a:ext uri="{FF2B5EF4-FFF2-40B4-BE49-F238E27FC236}">
                <a16:creationId xmlns:a16="http://schemas.microsoft.com/office/drawing/2014/main" id="{36AB1F05-AE5C-989F-7832-21FE92EA2F39}"/>
              </a:ext>
            </a:extLst>
          </p:cNvPr>
          <p:cNvSpPr/>
          <p:nvPr/>
        </p:nvSpPr>
        <p:spPr>
          <a:xfrm>
            <a:off x="369000" y="649059"/>
            <a:ext cx="6120000" cy="454705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FE241E9-6D7E-AAEE-1AF8-6CA95C3EED25}"/>
              </a:ext>
            </a:extLst>
          </p:cNvPr>
          <p:cNvSpPr txBox="1"/>
          <p:nvPr/>
        </p:nvSpPr>
        <p:spPr>
          <a:xfrm>
            <a:off x="437510" y="33606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E38082-D266-9B76-0FF9-54538F508890}"/>
              </a:ext>
            </a:extLst>
          </p:cNvPr>
          <p:cNvSpPr txBox="1"/>
          <p:nvPr/>
        </p:nvSpPr>
        <p:spPr>
          <a:xfrm>
            <a:off x="351450" y="5309979"/>
            <a:ext cx="6155100" cy="17192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>
              <a:lnSpc>
                <a:spcPct val="150000"/>
              </a:lnSpc>
              <a:spcAft>
                <a:spcPts val="500"/>
              </a:spcAft>
              <a:buNone/>
            </a:pP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Figure S2. Characteristics of mouse H1 promoter variants depicted in Figure. 1B. (A)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Representative images of NIH3T3 cells infected with lentiviruses carrying the five variants shown in </a:t>
            </a: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Figure. 1B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. Cells were imaged after puromycin selection.</a:t>
            </a: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(B) 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chematic summary of the five variants. O, exist; X, does not exist. Indel activities were arbitrarily determined based on the intensity of Cut bands in T7E1 assays (</a:t>
            </a: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Figure. 1C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), ranging from negative (–) to the strongest activity (+++).</a:t>
            </a:r>
            <a:endParaRPr lang="ko-KR" altLang="ko-KR" sz="12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9604830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1BA8B1-14C3-9A03-FB82-F6D2482EC5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AD58F11A-791D-D7C6-1A24-D57C4B26C742}"/>
              </a:ext>
            </a:extLst>
          </p:cNvPr>
          <p:cNvSpPr txBox="1"/>
          <p:nvPr/>
        </p:nvSpPr>
        <p:spPr>
          <a:xfrm>
            <a:off x="369000" y="643642"/>
            <a:ext cx="6120000" cy="31209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endParaRPr lang="ko-KR" alt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FFC103-4EB4-7906-8065-66F887950FB4}"/>
              </a:ext>
            </a:extLst>
          </p:cNvPr>
          <p:cNvSpPr txBox="1"/>
          <p:nvPr/>
        </p:nvSpPr>
        <p:spPr>
          <a:xfrm>
            <a:off x="543044" y="8649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6B1C061-61BA-83E9-5B11-81EAB478DF23}"/>
              </a:ext>
            </a:extLst>
          </p:cNvPr>
          <p:cNvSpPr txBox="1"/>
          <p:nvPr/>
        </p:nvSpPr>
        <p:spPr>
          <a:xfrm>
            <a:off x="3629380" y="217256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7">
            <a:extLst>
              <a:ext uri="{FF2B5EF4-FFF2-40B4-BE49-F238E27FC236}">
                <a16:creationId xmlns:a16="http://schemas.microsoft.com/office/drawing/2014/main" id="{E23A2969-5580-ED40-AD38-B31DF2392DD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96" t="28504" r="25613" b="59226"/>
          <a:stretch/>
        </p:blipFill>
        <p:spPr bwMode="auto">
          <a:xfrm>
            <a:off x="3863063" y="2738083"/>
            <a:ext cx="1550768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B99AE09A-2B41-AC94-801B-24840A3D0476}"/>
              </a:ext>
            </a:extLst>
          </p:cNvPr>
          <p:cNvSpPr txBox="1"/>
          <p:nvPr/>
        </p:nvSpPr>
        <p:spPr>
          <a:xfrm>
            <a:off x="5395724" y="2764195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sCpf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38EE10E-4639-3455-2721-87C6BEDA6BA2}"/>
              </a:ext>
            </a:extLst>
          </p:cNvPr>
          <p:cNvSpPr txBox="1"/>
          <p:nvPr/>
        </p:nvSpPr>
        <p:spPr>
          <a:xfrm>
            <a:off x="5395724" y="318283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Calibri"/>
                <a:cs typeface="Calibri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그림 33">
            <a:extLst>
              <a:ext uri="{FF2B5EF4-FFF2-40B4-BE49-F238E27FC236}">
                <a16:creationId xmlns:a16="http://schemas.microsoft.com/office/drawing/2014/main" id="{1944A9BE-F4F2-0896-75C2-8772C80B9A5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71" t="61470" r="26604" b="29563"/>
          <a:stretch/>
        </p:blipFill>
        <p:spPr>
          <a:xfrm>
            <a:off x="3863063" y="3156720"/>
            <a:ext cx="1550767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3DC5AF3-9AF5-77C1-DD56-92EEB6AD3DD6}"/>
              </a:ext>
            </a:extLst>
          </p:cNvPr>
          <p:cNvSpPr txBox="1"/>
          <p:nvPr/>
        </p:nvSpPr>
        <p:spPr>
          <a:xfrm>
            <a:off x="553153" y="217256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44C9B81-6A45-BFD0-5B55-FC255AC7E4EB}"/>
              </a:ext>
            </a:extLst>
          </p:cNvPr>
          <p:cNvSpPr txBox="1"/>
          <p:nvPr/>
        </p:nvSpPr>
        <p:spPr>
          <a:xfrm>
            <a:off x="2336157" y="3476963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ndel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그림 20">
            <a:extLst>
              <a:ext uri="{FF2B5EF4-FFF2-40B4-BE49-F238E27FC236}">
                <a16:creationId xmlns:a16="http://schemas.microsoft.com/office/drawing/2014/main" id="{40958321-87E6-30F2-47AB-68B803F7853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2518" t="29871" r="42933" b="31622"/>
          <a:stretch/>
        </p:blipFill>
        <p:spPr>
          <a:xfrm>
            <a:off x="904531" y="2746240"/>
            <a:ext cx="1440000" cy="720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A843E339-5337-0123-705C-00E05B429039}"/>
              </a:ext>
            </a:extLst>
          </p:cNvPr>
          <p:cNvSpPr txBox="1"/>
          <p:nvPr/>
        </p:nvSpPr>
        <p:spPr>
          <a:xfrm>
            <a:off x="812800" y="3476963"/>
            <a:ext cx="4384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665630F-7605-856B-6BD7-E5FEBEA1E6C5}"/>
              </a:ext>
            </a:extLst>
          </p:cNvPr>
          <p:cNvSpPr txBox="1"/>
          <p:nvPr/>
        </p:nvSpPr>
        <p:spPr>
          <a:xfrm>
            <a:off x="1171564" y="3476963"/>
            <a:ext cx="519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90.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42E4FF2-4EE3-CC75-F3FA-23BDD52E2EB1}"/>
              </a:ext>
            </a:extLst>
          </p:cNvPr>
          <p:cNvSpPr txBox="1"/>
          <p:nvPr/>
        </p:nvSpPr>
        <p:spPr>
          <a:xfrm>
            <a:off x="1553099" y="3476963"/>
            <a:ext cx="519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5.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B3231C-F5CE-DA49-5E7B-0FF0937FE02E}"/>
              </a:ext>
            </a:extLst>
          </p:cNvPr>
          <p:cNvSpPr txBox="1"/>
          <p:nvPr/>
        </p:nvSpPr>
        <p:spPr>
          <a:xfrm>
            <a:off x="1917164" y="3476963"/>
            <a:ext cx="519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4.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08ECA712-6F90-07AF-E7B9-5CB0233C0079}"/>
              </a:ext>
            </a:extLst>
          </p:cNvPr>
          <p:cNvGrpSpPr/>
          <p:nvPr/>
        </p:nvGrpSpPr>
        <p:grpSpPr>
          <a:xfrm>
            <a:off x="946712" y="2244643"/>
            <a:ext cx="1451926" cy="510749"/>
            <a:chOff x="946712" y="2239498"/>
            <a:chExt cx="1451926" cy="510749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3C57933-FB17-96B2-5750-7A9A7BBFB9A5}"/>
                </a:ext>
              </a:extLst>
            </p:cNvPr>
            <p:cNvSpPr txBox="1"/>
            <p:nvPr/>
          </p:nvSpPr>
          <p:spPr>
            <a:xfrm>
              <a:off x="1517800" y="2504026"/>
              <a:ext cx="530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83793BA-0FEB-23D5-8FF9-A9325FEF1D48}"/>
                </a:ext>
              </a:extLst>
            </p:cNvPr>
            <p:cNvSpPr txBox="1"/>
            <p:nvPr/>
          </p:nvSpPr>
          <p:spPr>
            <a:xfrm>
              <a:off x="1915814" y="2504026"/>
              <a:ext cx="4828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GH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C0A399F-ED57-0ED8-0ACB-D6B142AB5B70}"/>
                </a:ext>
              </a:extLst>
            </p:cNvPr>
            <p:cNvSpPr txBox="1"/>
            <p:nvPr/>
          </p:nvSpPr>
          <p:spPr>
            <a:xfrm>
              <a:off x="1148860" y="2504026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nti</a:t>
              </a:r>
              <a:endPara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13AD705-C69E-873D-E8B9-0950E32DC5B7}"/>
                </a:ext>
              </a:extLst>
            </p:cNvPr>
            <p:cNvSpPr txBox="1"/>
            <p:nvPr/>
          </p:nvSpPr>
          <p:spPr>
            <a:xfrm>
              <a:off x="946712" y="2504026"/>
              <a:ext cx="231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B6AFCFA2-8B9E-D9AF-40F7-DAE00A7ADB26}"/>
                </a:ext>
              </a:extLst>
            </p:cNvPr>
            <p:cNvCxnSpPr>
              <a:cxnSpLocks/>
            </p:cNvCxnSpPr>
            <p:nvPr/>
          </p:nvCxnSpPr>
          <p:spPr>
            <a:xfrm>
              <a:off x="1642073" y="2475269"/>
              <a:ext cx="6587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1FC08BE-C9A8-5E25-BCF6-432E60EB7580}"/>
                </a:ext>
              </a:extLst>
            </p:cNvPr>
            <p:cNvSpPr txBox="1"/>
            <p:nvPr/>
          </p:nvSpPr>
          <p:spPr>
            <a:xfrm>
              <a:off x="1743666" y="2239498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AV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7" name="TextBox 126">
            <a:extLst>
              <a:ext uri="{FF2B5EF4-FFF2-40B4-BE49-F238E27FC236}">
                <a16:creationId xmlns:a16="http://schemas.microsoft.com/office/drawing/2014/main" id="{0221C695-7CA0-F176-8FE2-A6115D75785F}"/>
              </a:ext>
            </a:extLst>
          </p:cNvPr>
          <p:cNvSpPr txBox="1"/>
          <p:nvPr/>
        </p:nvSpPr>
        <p:spPr>
          <a:xfrm>
            <a:off x="3817043" y="76574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algn="ctr">
              <a:defRPr kumimoji="1"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x-none" sz="10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22 </a:t>
            </a:r>
            <a:r>
              <a:rPr kumimoji="1" lang="en-US" altLang="x-none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p</a:t>
            </a:r>
            <a:endParaRPr kumimoji="1" lang="x-none" altLang="en-US" sz="10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ea typeface="+mn-ea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31C098AB-5170-A208-F9A7-480B563344C3}"/>
              </a:ext>
            </a:extLst>
          </p:cNvPr>
          <p:cNvSpPr txBox="1"/>
          <p:nvPr/>
        </p:nvSpPr>
        <p:spPr>
          <a:xfrm>
            <a:off x="3845136" y="187260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ko-KR"/>
            </a:defPPr>
            <a:lvl1pPr algn="ctr">
              <a:defRPr kumimoji="1"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x-none" sz="10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rPr>
              <a:t>208 bp</a:t>
            </a:r>
            <a:endParaRPr kumimoji="1" lang="x-none" altLang="en-US" sz="10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ea typeface="+mn-ea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504AEF4-55BF-1183-1149-780CB9D44A1A}"/>
              </a:ext>
            </a:extLst>
          </p:cNvPr>
          <p:cNvSpPr txBox="1"/>
          <p:nvPr/>
        </p:nvSpPr>
        <p:spPr>
          <a:xfrm>
            <a:off x="344018" y="3963735"/>
            <a:ext cx="6144982" cy="22732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Figure S3. Effect of poly(A) signals on CRISPR-AsCpf1 AAV with a bidirectional H1 promoter.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 </a:t>
            </a: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(A) 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AAV vectors targeting the </a:t>
            </a:r>
            <a:r>
              <a:rPr lang="en-US" altLang="ko-KR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Trp53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 locus were constructed using either SV40 or </a:t>
            </a:r>
            <a:r>
              <a:rPr lang="en-US" altLang="ko-KR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bGH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 poly(A) signals.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</a:t>
            </a: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(B)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 Different AAV particles derived from these constructs were used to infect NIH3T3 cells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50" charset="-127"/>
              </a:rPr>
              <a:t>.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After 3 days,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i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del mutants were also assayed by T7E1 assays, and then their frequencies (%) were determined by deep sequencing analyses using genomic DNA extracted from AAV-infected cells. 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Black arrowhead, uncut DNA fragments; red arrowhead, DNA fragments cleaved by T7E1; Indel (%), the results of deep sequencing analyses.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(</a:t>
            </a:r>
            <a:r>
              <a:rPr lang="en-US" altLang="ko-KR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C)</a:t>
            </a:r>
            <a:r>
              <a:rPr lang="en-US" altLang="ko-KR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 Western blot analysis of AsCpf1 expression. Beta-actin was used as a loading control. </a:t>
            </a:r>
            <a:endParaRPr lang="ko-KR" altLang="ko-KR" sz="12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68A0C7A3-DB29-62A5-F0DB-DCFC74F9117B}"/>
              </a:ext>
            </a:extLst>
          </p:cNvPr>
          <p:cNvCxnSpPr>
            <a:cxnSpLocks/>
          </p:cNvCxnSpPr>
          <p:nvPr/>
        </p:nvCxnSpPr>
        <p:spPr>
          <a:xfrm>
            <a:off x="1045972" y="1168648"/>
            <a:ext cx="3554068" cy="16778"/>
          </a:xfrm>
          <a:prstGeom prst="line">
            <a:avLst/>
          </a:prstGeo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순서도: 대체 처리 40">
            <a:extLst>
              <a:ext uri="{FF2B5EF4-FFF2-40B4-BE49-F238E27FC236}">
                <a16:creationId xmlns:a16="http://schemas.microsoft.com/office/drawing/2014/main" id="{DFD62829-AEDE-4587-920C-EE6DE02C1169}"/>
              </a:ext>
            </a:extLst>
          </p:cNvPr>
          <p:cNvSpPr/>
          <p:nvPr/>
        </p:nvSpPr>
        <p:spPr>
          <a:xfrm>
            <a:off x="4391704" y="997037"/>
            <a:ext cx="307332" cy="360000"/>
          </a:xfrm>
          <a:prstGeom prst="flowChartAlternateProcess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51B403B-7FF0-A8E9-64EF-92E869093D88}"/>
              </a:ext>
            </a:extLst>
          </p:cNvPr>
          <p:cNvSpPr txBox="1"/>
          <p:nvPr/>
        </p:nvSpPr>
        <p:spPr>
          <a:xfrm>
            <a:off x="4355417" y="1053927"/>
            <a:ext cx="391454" cy="246221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TR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3" name="순서도: 대체 처리 42">
            <a:extLst>
              <a:ext uri="{FF2B5EF4-FFF2-40B4-BE49-F238E27FC236}">
                <a16:creationId xmlns:a16="http://schemas.microsoft.com/office/drawing/2014/main" id="{F0100E29-5152-DF09-8319-9A03B7EF3AB7}"/>
              </a:ext>
            </a:extLst>
          </p:cNvPr>
          <p:cNvSpPr/>
          <p:nvPr/>
        </p:nvSpPr>
        <p:spPr>
          <a:xfrm>
            <a:off x="1017721" y="997037"/>
            <a:ext cx="307332" cy="360000"/>
          </a:xfrm>
          <a:prstGeom prst="flowChartAlternateProcess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4" name="왼쪽/오른쪽 화살표 49">
            <a:extLst>
              <a:ext uri="{FF2B5EF4-FFF2-40B4-BE49-F238E27FC236}">
                <a16:creationId xmlns:a16="http://schemas.microsoft.com/office/drawing/2014/main" id="{F7B3BD52-57B0-5889-23D1-3DE24D3717F5}"/>
              </a:ext>
            </a:extLst>
          </p:cNvPr>
          <p:cNvSpPr/>
          <p:nvPr/>
        </p:nvSpPr>
        <p:spPr>
          <a:xfrm>
            <a:off x="2176574" y="961037"/>
            <a:ext cx="676115" cy="432000"/>
          </a:xfrm>
          <a:prstGeom prst="leftRightArrow">
            <a:avLst/>
          </a:prstGeom>
          <a:solidFill>
            <a:schemeClr val="tx2">
              <a:lumMod val="50000"/>
              <a:lumOff val="50000"/>
            </a:schemeClr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E5C2405-F414-8F2B-DDB5-C7957B2ACF6E}"/>
              </a:ext>
            </a:extLst>
          </p:cNvPr>
          <p:cNvSpPr txBox="1"/>
          <p:nvPr/>
        </p:nvSpPr>
        <p:spPr>
          <a:xfrm>
            <a:off x="2300834" y="1053927"/>
            <a:ext cx="458780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P</a:t>
            </a:r>
            <a:r>
              <a:rPr kumimoji="0" lang="en-US" altLang="ko-KR" sz="1000" b="1" i="1" u="none" strike="noStrike" kern="1200" cap="none" spc="0" normalizeH="0" baseline="-25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1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순서도: 병합 45">
            <a:extLst>
              <a:ext uri="{FF2B5EF4-FFF2-40B4-BE49-F238E27FC236}">
                <a16:creationId xmlns:a16="http://schemas.microsoft.com/office/drawing/2014/main" id="{A19CC875-C8DF-26E3-8ABB-CCDA3F66E420}"/>
              </a:ext>
            </a:extLst>
          </p:cNvPr>
          <p:cNvSpPr>
            <a:spLocks/>
          </p:cNvSpPr>
          <p:nvPr/>
        </p:nvSpPr>
        <p:spPr>
          <a:xfrm rot="5400000">
            <a:off x="1774173" y="997588"/>
            <a:ext cx="360000" cy="358899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1FD2ACE-8930-4CBE-4FEE-0B686FACBC98}"/>
              </a:ext>
            </a:extLst>
          </p:cNvPr>
          <p:cNvSpPr txBox="1"/>
          <p:nvPr/>
        </p:nvSpPr>
        <p:spPr>
          <a:xfrm>
            <a:off x="1824574" y="1053927"/>
            <a:ext cx="370614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R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8" name="모서리가 둥근 직사각형 87">
            <a:extLst>
              <a:ext uri="{FF2B5EF4-FFF2-40B4-BE49-F238E27FC236}">
                <a16:creationId xmlns:a16="http://schemas.microsoft.com/office/drawing/2014/main" id="{B3DFE641-28C2-BBDB-6281-1EC89BD1CC22}"/>
              </a:ext>
            </a:extLst>
          </p:cNvPr>
          <p:cNvSpPr/>
          <p:nvPr/>
        </p:nvSpPr>
        <p:spPr>
          <a:xfrm>
            <a:off x="3847062" y="997037"/>
            <a:ext cx="504000" cy="360000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lvl="0" algn="ctr" defTabSz="914400" latinLnBrk="1">
              <a:defRPr/>
            </a:pPr>
            <a:r>
              <a:rPr lang="en-US" altLang="ko-K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V40</a:t>
            </a:r>
          </a:p>
          <a:p>
            <a:pPr lvl="0" algn="ctr" defTabSz="914400" latinLnBrk="1">
              <a:defRPr/>
            </a:pPr>
            <a:r>
              <a:rPr lang="en-US" altLang="ko-KR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lang="ko-KR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770DB0B-942F-015E-D6E4-78A9DE42C08E}"/>
              </a:ext>
            </a:extLst>
          </p:cNvPr>
          <p:cNvSpPr txBox="1"/>
          <p:nvPr/>
        </p:nvSpPr>
        <p:spPr>
          <a:xfrm>
            <a:off x="979494" y="1053927"/>
            <a:ext cx="391454" cy="246221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TR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0" name="모서리가 둥근 직사각형 68">
            <a:extLst>
              <a:ext uri="{FF2B5EF4-FFF2-40B4-BE49-F238E27FC236}">
                <a16:creationId xmlns:a16="http://schemas.microsoft.com/office/drawing/2014/main" id="{7275EE04-A0A6-650B-46E8-068775BE4D12}"/>
              </a:ext>
            </a:extLst>
          </p:cNvPr>
          <p:cNvSpPr/>
          <p:nvPr/>
        </p:nvSpPr>
        <p:spPr>
          <a:xfrm>
            <a:off x="2904996" y="997037"/>
            <a:ext cx="900000" cy="360000"/>
          </a:xfrm>
          <a:prstGeom prst="roundRect">
            <a:avLst/>
          </a:prstGeom>
          <a:solidFill>
            <a:schemeClr val="accent6">
              <a:lumMod val="75000"/>
            </a:schemeClr>
          </a:solidFill>
          <a:ln w="127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sCpf1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1" name="순서도: 대체 처리 50">
            <a:extLst>
              <a:ext uri="{FF2B5EF4-FFF2-40B4-BE49-F238E27FC236}">
                <a16:creationId xmlns:a16="http://schemas.microsoft.com/office/drawing/2014/main" id="{B7E5AF97-2FAE-3DB3-9801-2F64EEEAE894}"/>
              </a:ext>
            </a:extLst>
          </p:cNvPr>
          <p:cNvSpPr/>
          <p:nvPr/>
        </p:nvSpPr>
        <p:spPr>
          <a:xfrm>
            <a:off x="3696996" y="997037"/>
            <a:ext cx="108000" cy="360000"/>
          </a:xfrm>
          <a:prstGeom prst="flowChartAlternateProcess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2" name="순서도: 대체 처리 51">
            <a:extLst>
              <a:ext uri="{FF2B5EF4-FFF2-40B4-BE49-F238E27FC236}">
                <a16:creationId xmlns:a16="http://schemas.microsoft.com/office/drawing/2014/main" id="{E962FABF-D87D-BB1D-CA5E-3A1E2679BB14}"/>
              </a:ext>
            </a:extLst>
          </p:cNvPr>
          <p:cNvSpPr/>
          <p:nvPr/>
        </p:nvSpPr>
        <p:spPr>
          <a:xfrm>
            <a:off x="2904996" y="997037"/>
            <a:ext cx="108000" cy="360000"/>
          </a:xfrm>
          <a:prstGeom prst="flowChartAlternateProcess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3" name="모서리가 둥근 직사각형 46">
            <a:extLst>
              <a:ext uri="{FF2B5EF4-FFF2-40B4-BE49-F238E27FC236}">
                <a16:creationId xmlns:a16="http://schemas.microsoft.com/office/drawing/2014/main" id="{CADF5881-80B7-394C-2DB8-6F1D73F5FFAA}"/>
              </a:ext>
            </a:extLst>
          </p:cNvPr>
          <p:cNvSpPr/>
          <p:nvPr/>
        </p:nvSpPr>
        <p:spPr>
          <a:xfrm>
            <a:off x="1377769" y="997037"/>
            <a:ext cx="360000" cy="360000"/>
          </a:xfrm>
          <a:prstGeom prst="roundRect">
            <a:avLst/>
          </a:prstGeom>
          <a:solidFill>
            <a:srgbClr val="FFC00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67DFCC8-0CE6-383B-DCFF-C4BB67AF7575}"/>
              </a:ext>
            </a:extLst>
          </p:cNvPr>
          <p:cNvSpPr txBox="1"/>
          <p:nvPr/>
        </p:nvSpPr>
        <p:spPr>
          <a:xfrm>
            <a:off x="1288647" y="1053927"/>
            <a:ext cx="532518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>
            <a:defPPr>
              <a:defRPr lang="ko-KR"/>
            </a:defPPr>
            <a:lvl1pPr algn="ctr">
              <a:defRPr kumimoji="1"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p53</a:t>
            </a:r>
            <a:endParaRPr kumimoji="1" lang="ko-KR" altLang="en-US" sz="10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E3441ED4-4DA8-C494-43AB-B645BD3FB454}"/>
              </a:ext>
            </a:extLst>
          </p:cNvPr>
          <p:cNvCxnSpPr>
            <a:cxnSpLocks/>
          </p:cNvCxnSpPr>
          <p:nvPr/>
        </p:nvCxnSpPr>
        <p:spPr>
          <a:xfrm>
            <a:off x="1048094" y="1679369"/>
            <a:ext cx="3554068" cy="16778"/>
          </a:xfrm>
          <a:prstGeom prst="line">
            <a:avLst/>
          </a:prstGeo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순서도: 대체 처리 56">
            <a:extLst>
              <a:ext uri="{FF2B5EF4-FFF2-40B4-BE49-F238E27FC236}">
                <a16:creationId xmlns:a16="http://schemas.microsoft.com/office/drawing/2014/main" id="{DBB4A454-BDE2-3C8E-6223-E730DF1E4E1D}"/>
              </a:ext>
            </a:extLst>
          </p:cNvPr>
          <p:cNvSpPr/>
          <p:nvPr/>
        </p:nvSpPr>
        <p:spPr>
          <a:xfrm>
            <a:off x="4393826" y="1507758"/>
            <a:ext cx="307332" cy="360000"/>
          </a:xfrm>
          <a:prstGeom prst="flowChartAlternateProcess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3AFFC69-D90D-5F9D-EF2B-218254B60216}"/>
              </a:ext>
            </a:extLst>
          </p:cNvPr>
          <p:cNvSpPr txBox="1"/>
          <p:nvPr/>
        </p:nvSpPr>
        <p:spPr>
          <a:xfrm>
            <a:off x="4357539" y="1564648"/>
            <a:ext cx="391454" cy="246221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TR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9" name="순서도: 대체 처리 58">
            <a:extLst>
              <a:ext uri="{FF2B5EF4-FFF2-40B4-BE49-F238E27FC236}">
                <a16:creationId xmlns:a16="http://schemas.microsoft.com/office/drawing/2014/main" id="{8EAD0D46-F48C-983A-BB61-D404E4DAD330}"/>
              </a:ext>
            </a:extLst>
          </p:cNvPr>
          <p:cNvSpPr/>
          <p:nvPr/>
        </p:nvSpPr>
        <p:spPr>
          <a:xfrm>
            <a:off x="1019843" y="1507758"/>
            <a:ext cx="307332" cy="360000"/>
          </a:xfrm>
          <a:prstGeom prst="flowChartAlternateProcess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0" name="왼쪽/오른쪽 화살표 49">
            <a:extLst>
              <a:ext uri="{FF2B5EF4-FFF2-40B4-BE49-F238E27FC236}">
                <a16:creationId xmlns:a16="http://schemas.microsoft.com/office/drawing/2014/main" id="{BB622088-6F23-4B81-8E8D-303C7F2E1577}"/>
              </a:ext>
            </a:extLst>
          </p:cNvPr>
          <p:cNvSpPr/>
          <p:nvPr/>
        </p:nvSpPr>
        <p:spPr>
          <a:xfrm>
            <a:off x="2178696" y="1471758"/>
            <a:ext cx="676115" cy="432000"/>
          </a:xfrm>
          <a:prstGeom prst="leftRightArrow">
            <a:avLst/>
          </a:prstGeom>
          <a:solidFill>
            <a:schemeClr val="tx2">
              <a:lumMod val="50000"/>
              <a:lumOff val="50000"/>
            </a:schemeClr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ko-KR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EE0AA8C-328B-4E4F-9792-45AE6A234754}"/>
              </a:ext>
            </a:extLst>
          </p:cNvPr>
          <p:cNvSpPr txBox="1"/>
          <p:nvPr/>
        </p:nvSpPr>
        <p:spPr>
          <a:xfrm>
            <a:off x="2302956" y="1564648"/>
            <a:ext cx="458780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P</a:t>
            </a:r>
            <a:r>
              <a:rPr kumimoji="0" lang="en-US" altLang="ko-KR" sz="1000" b="1" i="1" u="none" strike="noStrike" kern="1200" cap="none" spc="0" normalizeH="0" baseline="-25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1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2" name="순서도: 병합 61">
            <a:extLst>
              <a:ext uri="{FF2B5EF4-FFF2-40B4-BE49-F238E27FC236}">
                <a16:creationId xmlns:a16="http://schemas.microsoft.com/office/drawing/2014/main" id="{DA47F94A-BB1D-72B1-6E8E-E550E852C34C}"/>
              </a:ext>
            </a:extLst>
          </p:cNvPr>
          <p:cNvSpPr>
            <a:spLocks/>
          </p:cNvSpPr>
          <p:nvPr/>
        </p:nvSpPr>
        <p:spPr>
          <a:xfrm rot="5400000">
            <a:off x="1776295" y="1508309"/>
            <a:ext cx="360000" cy="358899"/>
          </a:xfrm>
          <a:prstGeom prst="flowChartMerg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0175DA9-6FB3-2F91-3E4F-2ABA89AA1F30}"/>
              </a:ext>
            </a:extLst>
          </p:cNvPr>
          <p:cNvSpPr txBox="1"/>
          <p:nvPr/>
        </p:nvSpPr>
        <p:spPr>
          <a:xfrm>
            <a:off x="1826696" y="1564648"/>
            <a:ext cx="370614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R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4" name="모서리가 둥근 직사각형 87">
            <a:extLst>
              <a:ext uri="{FF2B5EF4-FFF2-40B4-BE49-F238E27FC236}">
                <a16:creationId xmlns:a16="http://schemas.microsoft.com/office/drawing/2014/main" id="{F7BEA3E8-84CB-ABC8-4CB1-26211C9AD15D}"/>
              </a:ext>
            </a:extLst>
          </p:cNvPr>
          <p:cNvSpPr/>
          <p:nvPr/>
        </p:nvSpPr>
        <p:spPr>
          <a:xfrm>
            <a:off x="3849184" y="1507758"/>
            <a:ext cx="504000" cy="360000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lvl="0" algn="ctr" defTabSz="914400" latinLnBrk="1">
              <a:defRPr/>
            </a:pPr>
            <a:r>
              <a:rPr lang="en-US" altLang="ko-KR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GH</a:t>
            </a:r>
            <a:endParaRPr lang="en-US" altLang="ko-KR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 defTabSz="914400" latinLnBrk="1">
              <a:defRPr/>
            </a:pPr>
            <a:r>
              <a:rPr lang="en-US" altLang="ko-KR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lang="ko-KR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581EEA6-15D9-3E1A-D7C0-931058F866EF}"/>
              </a:ext>
            </a:extLst>
          </p:cNvPr>
          <p:cNvSpPr txBox="1"/>
          <p:nvPr/>
        </p:nvSpPr>
        <p:spPr>
          <a:xfrm>
            <a:off x="981616" y="1564648"/>
            <a:ext cx="391454" cy="246221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TR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6" name="모서리가 둥근 직사각형 68">
            <a:extLst>
              <a:ext uri="{FF2B5EF4-FFF2-40B4-BE49-F238E27FC236}">
                <a16:creationId xmlns:a16="http://schemas.microsoft.com/office/drawing/2014/main" id="{1E60912D-41E5-327F-6F2A-ED9FBBF4EA69}"/>
              </a:ext>
            </a:extLst>
          </p:cNvPr>
          <p:cNvSpPr/>
          <p:nvPr/>
        </p:nvSpPr>
        <p:spPr>
          <a:xfrm>
            <a:off x="2907118" y="1507758"/>
            <a:ext cx="900000" cy="360000"/>
          </a:xfrm>
          <a:prstGeom prst="roundRect">
            <a:avLst/>
          </a:prstGeom>
          <a:solidFill>
            <a:schemeClr val="accent6">
              <a:lumMod val="75000"/>
            </a:schemeClr>
          </a:solidFill>
          <a:ln w="1270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sCpf1</a:t>
            </a:r>
            <a:endParaRPr kumimoji="0" lang="ko-KR" altLang="en-US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7" name="순서도: 대체 처리 66">
            <a:extLst>
              <a:ext uri="{FF2B5EF4-FFF2-40B4-BE49-F238E27FC236}">
                <a16:creationId xmlns:a16="http://schemas.microsoft.com/office/drawing/2014/main" id="{1A006863-7574-66E8-92F7-37B5575A63AC}"/>
              </a:ext>
            </a:extLst>
          </p:cNvPr>
          <p:cNvSpPr/>
          <p:nvPr/>
        </p:nvSpPr>
        <p:spPr>
          <a:xfrm>
            <a:off x="3699118" y="1507758"/>
            <a:ext cx="108000" cy="360000"/>
          </a:xfrm>
          <a:prstGeom prst="flowChartAlternateProcess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8" name="순서도: 대체 처리 67">
            <a:extLst>
              <a:ext uri="{FF2B5EF4-FFF2-40B4-BE49-F238E27FC236}">
                <a16:creationId xmlns:a16="http://schemas.microsoft.com/office/drawing/2014/main" id="{6821C6F5-EED4-0988-AC88-C9059FB31CFA}"/>
              </a:ext>
            </a:extLst>
          </p:cNvPr>
          <p:cNvSpPr/>
          <p:nvPr/>
        </p:nvSpPr>
        <p:spPr>
          <a:xfrm>
            <a:off x="2907118" y="1507758"/>
            <a:ext cx="108000" cy="360000"/>
          </a:xfrm>
          <a:prstGeom prst="flowChartAlternateProcess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9" name="모서리가 둥근 직사각형 46">
            <a:extLst>
              <a:ext uri="{FF2B5EF4-FFF2-40B4-BE49-F238E27FC236}">
                <a16:creationId xmlns:a16="http://schemas.microsoft.com/office/drawing/2014/main" id="{72AA5C90-58C1-26E4-2A3A-CCF95B9657E1}"/>
              </a:ext>
            </a:extLst>
          </p:cNvPr>
          <p:cNvSpPr/>
          <p:nvPr/>
        </p:nvSpPr>
        <p:spPr>
          <a:xfrm>
            <a:off x="1379891" y="1507758"/>
            <a:ext cx="360000" cy="360000"/>
          </a:xfrm>
          <a:prstGeom prst="roundRect">
            <a:avLst/>
          </a:prstGeom>
          <a:solidFill>
            <a:srgbClr val="FFC00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5D877FB-E7AB-9612-E236-F3AB52849D15}"/>
              </a:ext>
            </a:extLst>
          </p:cNvPr>
          <p:cNvSpPr txBox="1"/>
          <p:nvPr/>
        </p:nvSpPr>
        <p:spPr>
          <a:xfrm>
            <a:off x="1290769" y="1564648"/>
            <a:ext cx="532518" cy="24622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none" rtlCol="0">
            <a:spAutoFit/>
          </a:bodyPr>
          <a:lstStyle>
            <a:defPPr>
              <a:defRPr lang="ko-KR"/>
            </a:defPPr>
            <a:lvl1pPr algn="ctr">
              <a:defRPr kumimoji="1"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1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p53</a:t>
            </a:r>
            <a:endParaRPr kumimoji="1" lang="ko-KR" altLang="en-US" sz="10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296E838C-EDEB-8CE3-626C-A9AB001A88A7}"/>
              </a:ext>
            </a:extLst>
          </p:cNvPr>
          <p:cNvGrpSpPr/>
          <p:nvPr/>
        </p:nvGrpSpPr>
        <p:grpSpPr>
          <a:xfrm>
            <a:off x="3979303" y="2244643"/>
            <a:ext cx="1451926" cy="510749"/>
            <a:chOff x="3979303" y="2212893"/>
            <a:chExt cx="1451926" cy="510749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4BC2167C-DFF7-0263-B661-AEA32E5FFF6D}"/>
                </a:ext>
              </a:extLst>
            </p:cNvPr>
            <p:cNvSpPr txBox="1"/>
            <p:nvPr/>
          </p:nvSpPr>
          <p:spPr>
            <a:xfrm>
              <a:off x="4550391" y="2477421"/>
              <a:ext cx="5309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V4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ED61EEDF-0B87-F6F1-7BFC-71D1988B96E3}"/>
                </a:ext>
              </a:extLst>
            </p:cNvPr>
            <p:cNvSpPr txBox="1"/>
            <p:nvPr/>
          </p:nvSpPr>
          <p:spPr>
            <a:xfrm>
              <a:off x="4948405" y="2477421"/>
              <a:ext cx="4828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GH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92041DB-7A89-3BD0-BF7A-08EBD6C6EA5A}"/>
                </a:ext>
              </a:extLst>
            </p:cNvPr>
            <p:cNvSpPr txBox="1"/>
            <p:nvPr/>
          </p:nvSpPr>
          <p:spPr>
            <a:xfrm>
              <a:off x="4181451" y="2477421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nti</a:t>
              </a:r>
              <a:endPara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55080FA-1D48-278F-541E-67E1A2126745}"/>
                </a:ext>
              </a:extLst>
            </p:cNvPr>
            <p:cNvSpPr txBox="1"/>
            <p:nvPr/>
          </p:nvSpPr>
          <p:spPr>
            <a:xfrm>
              <a:off x="3979303" y="2477421"/>
              <a:ext cx="231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직선 연결선 76">
              <a:extLst>
                <a:ext uri="{FF2B5EF4-FFF2-40B4-BE49-F238E27FC236}">
                  <a16:creationId xmlns:a16="http://schemas.microsoft.com/office/drawing/2014/main" id="{BEEBBB50-4F89-E5F1-A7A1-C1D3C870C308}"/>
                </a:ext>
              </a:extLst>
            </p:cNvPr>
            <p:cNvCxnSpPr>
              <a:cxnSpLocks/>
            </p:cNvCxnSpPr>
            <p:nvPr/>
          </p:nvCxnSpPr>
          <p:spPr>
            <a:xfrm>
              <a:off x="4674664" y="2448664"/>
              <a:ext cx="6587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34359D54-E4FE-EEEC-A3B7-4AD8A6D1FF6E}"/>
                </a:ext>
              </a:extLst>
            </p:cNvPr>
            <p:cNvSpPr txBox="1"/>
            <p:nvPr/>
          </p:nvSpPr>
          <p:spPr>
            <a:xfrm>
              <a:off x="4776257" y="2212893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AV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2" name="그룹 81">
            <a:extLst>
              <a:ext uri="{FF2B5EF4-FFF2-40B4-BE49-F238E27FC236}">
                <a16:creationId xmlns:a16="http://schemas.microsoft.com/office/drawing/2014/main" id="{5C70955E-F319-1879-FD31-FC1F4764E698}"/>
              </a:ext>
            </a:extLst>
          </p:cNvPr>
          <p:cNvGrpSpPr/>
          <p:nvPr/>
        </p:nvGrpSpPr>
        <p:grpSpPr>
          <a:xfrm>
            <a:off x="2353790" y="2735459"/>
            <a:ext cx="700833" cy="261610"/>
            <a:chOff x="4148619" y="4010920"/>
            <a:chExt cx="700833" cy="261610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EDCB51D-298E-91F3-7BD9-80D4A763403A}"/>
                </a:ext>
              </a:extLst>
            </p:cNvPr>
            <p:cNvSpPr txBox="1"/>
            <p:nvPr/>
          </p:nvSpPr>
          <p:spPr>
            <a:xfrm>
              <a:off x="4148619" y="4010920"/>
              <a:ext cx="7008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  Uncut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이등변 삼각형 83">
              <a:extLst>
                <a:ext uri="{FF2B5EF4-FFF2-40B4-BE49-F238E27FC236}">
                  <a16:creationId xmlns:a16="http://schemas.microsoft.com/office/drawing/2014/main" id="{356A352F-D6DE-B80B-EBF4-7AC3E4498D21}"/>
                </a:ext>
              </a:extLst>
            </p:cNvPr>
            <p:cNvSpPr/>
            <p:nvPr/>
          </p:nvSpPr>
          <p:spPr>
            <a:xfrm rot="16200000">
              <a:off x="4231792" y="4096725"/>
              <a:ext cx="54000" cy="900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그룹 84">
            <a:extLst>
              <a:ext uri="{FF2B5EF4-FFF2-40B4-BE49-F238E27FC236}">
                <a16:creationId xmlns:a16="http://schemas.microsoft.com/office/drawing/2014/main" id="{632C8132-9F60-D03C-3F33-E1FF9B88FCA3}"/>
              </a:ext>
            </a:extLst>
          </p:cNvPr>
          <p:cNvGrpSpPr/>
          <p:nvPr/>
        </p:nvGrpSpPr>
        <p:grpSpPr>
          <a:xfrm>
            <a:off x="2353790" y="3106939"/>
            <a:ext cx="535724" cy="261610"/>
            <a:chOff x="4148619" y="4406217"/>
            <a:chExt cx="535724" cy="261610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5B5F5625-CFFA-3D0C-06A3-9C44FBFEBDB0}"/>
                </a:ext>
              </a:extLst>
            </p:cNvPr>
            <p:cNvSpPr txBox="1"/>
            <p:nvPr/>
          </p:nvSpPr>
          <p:spPr>
            <a:xfrm>
              <a:off x="4148619" y="4406217"/>
              <a:ext cx="5357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Cut</a:t>
              </a:r>
              <a:endParaRPr lang="ko-KR" altLang="en-US" sz="105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7" name="그룹 86">
              <a:extLst>
                <a:ext uri="{FF2B5EF4-FFF2-40B4-BE49-F238E27FC236}">
                  <a16:creationId xmlns:a16="http://schemas.microsoft.com/office/drawing/2014/main" id="{A2FFB9AE-CBB5-0858-7F01-A26539B049EC}"/>
                </a:ext>
              </a:extLst>
            </p:cNvPr>
            <p:cNvGrpSpPr/>
            <p:nvPr/>
          </p:nvGrpSpPr>
          <p:grpSpPr>
            <a:xfrm>
              <a:off x="4213792" y="4439597"/>
              <a:ext cx="90000" cy="194851"/>
              <a:chOff x="4213792" y="4448871"/>
              <a:chExt cx="90000" cy="194851"/>
            </a:xfrm>
          </p:grpSpPr>
          <p:sp>
            <p:nvSpPr>
              <p:cNvPr id="88" name="이등변 삼각형 87">
                <a:extLst>
                  <a:ext uri="{FF2B5EF4-FFF2-40B4-BE49-F238E27FC236}">
                    <a16:creationId xmlns:a16="http://schemas.microsoft.com/office/drawing/2014/main" id="{6C0DABE9-D893-4306-573B-DFA4D2CC0B84}"/>
                  </a:ext>
                </a:extLst>
              </p:cNvPr>
              <p:cNvSpPr/>
              <p:nvPr/>
            </p:nvSpPr>
            <p:spPr>
              <a:xfrm rot="16200000">
                <a:off x="4231792" y="4430871"/>
                <a:ext cx="54000" cy="90000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이등변 삼각형 88">
                <a:extLst>
                  <a:ext uri="{FF2B5EF4-FFF2-40B4-BE49-F238E27FC236}">
                    <a16:creationId xmlns:a16="http://schemas.microsoft.com/office/drawing/2014/main" id="{31E4CC49-E2F7-A7EF-CFF0-FA413127E107}"/>
                  </a:ext>
                </a:extLst>
              </p:cNvPr>
              <p:cNvSpPr/>
              <p:nvPr/>
            </p:nvSpPr>
            <p:spPr>
              <a:xfrm rot="16200000">
                <a:off x="4231792" y="4571722"/>
                <a:ext cx="54000" cy="90000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944048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03D6B323-3C84-7020-CC9A-1B45C0B49B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4972054"/>
              </p:ext>
            </p:extLst>
          </p:nvPr>
        </p:nvGraphicFramePr>
        <p:xfrm>
          <a:off x="224943" y="450878"/>
          <a:ext cx="6500190" cy="1585885"/>
        </p:xfrm>
        <a:graphic>
          <a:graphicData uri="http://schemas.openxmlformats.org/drawingml/2006/table">
            <a:tbl>
              <a:tblPr firstRow="1" firstCol="1" bandRow="1"/>
              <a:tblGrid>
                <a:gridCol w="1356006">
                  <a:extLst>
                    <a:ext uri="{9D8B030D-6E8A-4147-A177-3AD203B41FA5}">
                      <a16:colId xmlns:a16="http://schemas.microsoft.com/office/drawing/2014/main" val="3878283352"/>
                    </a:ext>
                  </a:extLst>
                </a:gridCol>
                <a:gridCol w="5144184">
                  <a:extLst>
                    <a:ext uri="{9D8B030D-6E8A-4147-A177-3AD203B41FA5}">
                      <a16:colId xmlns:a16="http://schemas.microsoft.com/office/drawing/2014/main" val="503958715"/>
                    </a:ext>
                  </a:extLst>
                </a:gridCol>
              </a:tblGrid>
              <a:tr h="226555"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altLang="ko-KR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arget locus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Overhang sequence (5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3)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5174554"/>
                  </a:ext>
                </a:extLst>
              </a:tr>
              <a:tr h="226555">
                <a:tc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000" b="1" i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p53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overhang-F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ACTCTTTCCCTACACGACGCTCTTCCGATCTTCTCCCGGCTTCTGACTTAT</a:t>
                      </a: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513741"/>
                  </a:ext>
                </a:extLst>
              </a:tr>
              <a:tr h="226555">
                <a:tc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000" b="1" i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p53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overhang-R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TGACTGGAGTTCAGACGTGTGCTCTTCCGATCTGGAGGGTGAGGCAAACGGGT</a:t>
                      </a: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4423250"/>
                  </a:ext>
                </a:extLst>
              </a:tr>
              <a:tr h="226555">
                <a:tc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000" b="1" i="1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overhang-F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ACTCTTTCCCTACACGACGCTCTTCCGATCTACCGCCAAGTCCAGAGCCAT</a:t>
                      </a: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808699"/>
                  </a:ext>
                </a:extLst>
              </a:tr>
              <a:tr h="226555">
                <a:tc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000" b="1" i="1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overhang-R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TGACTGGAGTTCAGACGTGTGCTCTTCCGATCTGTCTACTCCCACGTTATCAG</a:t>
                      </a: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5907489"/>
                  </a:ext>
                </a:extLst>
              </a:tr>
              <a:tr h="226555">
                <a:tc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000" b="1" i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f1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overhang-F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ACTCTTTCCCTACACGACGCTCTTCCGATCTCCTGCCGTGAAGGAAACCAA</a:t>
                      </a: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5404406"/>
                  </a:ext>
                </a:extLst>
              </a:tr>
              <a:tr h="226555">
                <a:tc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000" b="1" i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f1</a:t>
                      </a: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overhang-R</a:t>
                      </a:r>
                      <a:endParaRPr lang="ko-KR" sz="10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TGACTGGAGTTCAGACGTGTGCTCTTCCGATCTGTCATTCTGTTAACCACTCT</a:t>
                      </a: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888473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CC932E9-0A1E-C6B1-B006-898BC0A0D611}"/>
              </a:ext>
            </a:extLst>
          </p:cNvPr>
          <p:cNvSpPr txBox="1"/>
          <p:nvPr/>
        </p:nvSpPr>
        <p:spPr>
          <a:xfrm>
            <a:off x="224943" y="101600"/>
            <a:ext cx="30628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Overhang PCR primer sequences.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62334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39D8D93-F517-6317-D24D-D2E30C9C1B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7E2F8E0F-9389-9165-3B46-08A362649A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0272523"/>
              </p:ext>
            </p:extLst>
          </p:nvPr>
        </p:nvGraphicFramePr>
        <p:xfrm>
          <a:off x="224943" y="450878"/>
          <a:ext cx="6500190" cy="4630981"/>
        </p:xfrm>
        <a:graphic>
          <a:graphicData uri="http://schemas.openxmlformats.org/drawingml/2006/table">
            <a:tbl>
              <a:tblPr firstRow="1" firstCol="1" bandRow="1"/>
              <a:tblGrid>
                <a:gridCol w="563951">
                  <a:extLst>
                    <a:ext uri="{9D8B030D-6E8A-4147-A177-3AD203B41FA5}">
                      <a16:colId xmlns:a16="http://schemas.microsoft.com/office/drawing/2014/main" val="3878283352"/>
                    </a:ext>
                  </a:extLst>
                </a:gridCol>
                <a:gridCol w="870300">
                  <a:extLst>
                    <a:ext uri="{9D8B030D-6E8A-4147-A177-3AD203B41FA5}">
                      <a16:colId xmlns:a16="http://schemas.microsoft.com/office/drawing/2014/main" val="2099808005"/>
                    </a:ext>
                  </a:extLst>
                </a:gridCol>
                <a:gridCol w="5065939">
                  <a:extLst>
                    <a:ext uri="{9D8B030D-6E8A-4147-A177-3AD203B41FA5}">
                      <a16:colId xmlns:a16="http://schemas.microsoft.com/office/drawing/2014/main" val="503958715"/>
                    </a:ext>
                  </a:extLst>
                </a:gridCol>
              </a:tblGrid>
              <a:tr h="463099">
                <a:tc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r>
                        <a:rPr lang="en-US" altLang="ko-KR" sz="11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arget gene</a:t>
                      </a:r>
                      <a:endParaRPr lang="ko-KR" sz="1100" b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ample name</a:t>
                      </a:r>
                      <a:endParaRPr lang="ko-KR" altLang="ko-KR" sz="1100" b="1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dex sequence </a:t>
                      </a:r>
                      <a:r>
                        <a:rPr lang="en-US" altLang="ko-KR" sz="1100" b="1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5</a:t>
                      </a:r>
                      <a:r>
                        <a:rPr lang="en-US" altLang="ko-KR" sz="1100" b="1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3)</a:t>
                      </a:r>
                      <a:endParaRPr lang="ko-KR" altLang="ko-KR" sz="1100" b="1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5174554"/>
                  </a:ext>
                </a:extLst>
              </a:tr>
              <a:tr h="231549">
                <a:tc rowSpan="8"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altLang="ko-KR" sz="1000" b="1" i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p53</a:t>
                      </a:r>
                      <a:endParaRPr lang="ko-KR" sz="1000" b="1" i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gative control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CAGGACGT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513741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TTCTGAAT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9587048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53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rgeted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GTACTGAC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4423250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TTCTGAAT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969270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53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TATAGCCT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808699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2636819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53, </a:t>
                      </a:r>
                      <a:r>
                        <a:rPr lang="en-US" altLang="ko-KR" sz="1000" b="1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amp;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f1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rgeted 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ATAGAGGC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5907489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486154"/>
                  </a:ext>
                </a:extLst>
              </a:tr>
              <a:tr h="231549">
                <a:tc rowSpan="6"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altLang="ko-KR" sz="1000" b="1" i="1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ten</a:t>
                      </a:r>
                      <a:endParaRPr lang="ko-KR" sz="1000" b="1" i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gative control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CCTATCCT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5404406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5051048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53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GGCTCTGA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8884735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8289292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53, </a:t>
                      </a:r>
                      <a:r>
                        <a:rPr lang="en-US" altLang="ko-KR" sz="1000" b="1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amp;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f1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rgeted 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AGGCGAAG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5123949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8061784"/>
                  </a:ext>
                </a:extLst>
              </a:tr>
              <a:tr h="231549">
                <a:tc rowSpan="4">
                  <a:txBody>
                    <a:bodyPr/>
                    <a:lstStyle/>
                    <a:p>
                      <a:pPr algn="l" latinLnBrk="1">
                        <a:spcAft>
                          <a:spcPts val="800"/>
                        </a:spcAft>
                        <a:buNone/>
                      </a:pPr>
                      <a:r>
                        <a:rPr lang="en-US" altLang="ko-KR" sz="1000" b="1" i="1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f1</a:t>
                      </a:r>
                      <a:endParaRPr lang="ko-KR" sz="1000" b="1" i="1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gative control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TAATCTTA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0406827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6064332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algn="ctr" latinLnBrk="1">
                        <a:spcAft>
                          <a:spcPts val="800"/>
                        </a:spcAft>
                        <a:buNone/>
                      </a:pPr>
                      <a:endParaRPr lang="ko-KR" sz="10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53, </a:t>
                      </a:r>
                      <a:r>
                        <a:rPr lang="en-US" altLang="ko-KR" sz="1000" b="1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amp;</a:t>
                      </a:r>
                      <a:r>
                        <a:rPr lang="en-US" altLang="ko-KR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f1</a:t>
                      </a:r>
                      <a:r>
                        <a:rPr lang="en-US" altLang="ko-KR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rgeted </a:t>
                      </a:r>
                      <a:endParaRPr lang="ko-KR" altLang="ko-KR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ATGATACGGCGACCACCGAGATCTACACCAGGACGTACACTCTTTCCCTACACGA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8205731"/>
                  </a:ext>
                </a:extLst>
              </a:tr>
              <a:tr h="231549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AGCAGAAGACGGCATACGAGATACGAATTCGTGACTGGAGTTCAGACGTG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93412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4046266-A36C-D43A-37B7-47B006E3D170}"/>
              </a:ext>
            </a:extLst>
          </p:cNvPr>
          <p:cNvSpPr txBox="1"/>
          <p:nvPr/>
        </p:nvSpPr>
        <p:spPr>
          <a:xfrm>
            <a:off x="224943" y="101600"/>
            <a:ext cx="27790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Index PCR primer sequences.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5495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83</TotalTime>
  <Words>539</Words>
  <Application>Microsoft Office PowerPoint</Application>
  <PresentationFormat>A4 용지(210x297mm)</PresentationFormat>
  <Paragraphs>172</Paragraphs>
  <Slides>5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4" baseType="lpstr">
      <vt:lpstr>굴림</vt:lpstr>
      <vt:lpstr>맑은 고딕</vt:lpstr>
      <vt:lpstr>Aptos</vt:lpstr>
      <vt:lpstr>Aptos Display</vt:lpstr>
      <vt:lpstr>Arial</vt:lpstr>
      <vt:lpstr>Calibri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김수민</dc:creator>
  <cp:lastModifiedBy>정연주</cp:lastModifiedBy>
  <cp:revision>260</cp:revision>
  <dcterms:created xsi:type="dcterms:W3CDTF">2024-10-11T08:19:07Z</dcterms:created>
  <dcterms:modified xsi:type="dcterms:W3CDTF">2026-05-06T00:32:25Z</dcterms:modified>
</cp:coreProperties>
</file>